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69102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76306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93400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20244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96444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93699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15467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11807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37012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64147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53534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F7244-0E19-A045-A537-AF6003D521C4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48CA44-F386-0A41-989C-2309807F1B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11935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60145" y="4154265"/>
            <a:ext cx="4966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 smtClean="0">
                <a:latin typeface="Arial"/>
                <a:cs typeface="Arial"/>
              </a:rPr>
              <a:t>HOXA</a:t>
            </a:r>
            <a:endParaRPr lang="en-US" sz="800" i="1" dirty="0">
              <a:latin typeface="Arial"/>
              <a:cs typeface="Arial"/>
            </a:endParaRPr>
          </a:p>
        </p:txBody>
      </p:sp>
      <p:cxnSp>
        <p:nvCxnSpPr>
          <p:cNvPr id="5" name="Straight Arrow Connector 4"/>
          <p:cNvCxnSpPr/>
          <p:nvPr/>
        </p:nvCxnSpPr>
        <p:spPr>
          <a:xfrm flipH="1">
            <a:off x="1776448" y="4370850"/>
            <a:ext cx="220134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638928" y="1005884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7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38928" y="1229470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6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38928" y="1453056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7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38928" y="1676642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6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13280" y="1900228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8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38928" y="2347400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9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13280" y="2570986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6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38928" y="2794572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7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13280" y="3018161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6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38928" y="2123814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9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50737" y="1721558"/>
            <a:ext cx="5696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3K27me3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34682" y="1053269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6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34682" y="1276032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7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34682" y="1498795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8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93530" y="1944321"/>
            <a:ext cx="52681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3K4me3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50737" y="2835373"/>
            <a:ext cx="5696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3K27me3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34682" y="2167084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6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34682" y="2389847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7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34682" y="2612610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8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93530" y="3058132"/>
            <a:ext cx="52681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3K4me3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883148" y="700126"/>
            <a:ext cx="3728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10 kb</a:t>
            </a:r>
            <a:endParaRPr lang="en-US" sz="600" dirty="0">
              <a:latin typeface="Arial"/>
              <a:cs typeface="Arial"/>
            </a:endParaRPr>
          </a:p>
        </p:txBody>
      </p:sp>
      <p:pic>
        <p:nvPicPr>
          <p:cNvPr id="28" name="Picture 27" descr="Screen Shot 2013-02-19 at 17.02.38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22333" y="881220"/>
            <a:ext cx="2754098" cy="2520000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4633941" y="4154409"/>
            <a:ext cx="5004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 smtClean="0">
                <a:latin typeface="Arial"/>
                <a:cs typeface="Arial"/>
              </a:rPr>
              <a:t>HOXB</a:t>
            </a:r>
            <a:endParaRPr lang="en-US" sz="800" i="1" dirty="0">
              <a:latin typeface="Arial"/>
              <a:cs typeface="Arial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 flipH="1">
            <a:off x="4750244" y="4370994"/>
            <a:ext cx="220134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631642" y="998773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1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631642" y="1220300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3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631642" y="144182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8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657290" y="1663354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9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631642" y="1884881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3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631642" y="2327935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3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631642" y="2549462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25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657290" y="2770989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9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631642" y="2992514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2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631642" y="2106408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3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772484" y="1403154"/>
            <a:ext cx="3728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10 kb</a:t>
            </a:r>
            <a:endParaRPr lang="en-US" sz="600" dirty="0">
              <a:latin typeface="Arial"/>
              <a:cs typeface="Arial"/>
            </a:endParaRPr>
          </a:p>
        </p:txBody>
      </p:sp>
      <p:pic>
        <p:nvPicPr>
          <p:cNvPr id="53" name="Picture 52" descr="Screen Shot 2013-02-19 at 17.06.26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" r="1404"/>
          <a:stretch/>
        </p:blipFill>
        <p:spPr>
          <a:xfrm>
            <a:off x="3825968" y="865986"/>
            <a:ext cx="2263216" cy="2535234"/>
          </a:xfrm>
          <a:prstGeom prst="rect">
            <a:avLst/>
          </a:prstGeom>
        </p:spPr>
      </p:pic>
      <p:pic>
        <p:nvPicPr>
          <p:cNvPr id="2" name="Picture 1" descr="Screen Shot 2013-02-26 at 14.24.05.png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516" t="4890" r="4188" b="-1"/>
          <a:stretch/>
        </p:blipFill>
        <p:spPr>
          <a:xfrm>
            <a:off x="817536" y="3289312"/>
            <a:ext cx="2754099" cy="846667"/>
          </a:xfrm>
          <a:prstGeom prst="rect">
            <a:avLst/>
          </a:prstGeom>
        </p:spPr>
      </p:pic>
      <p:sp>
        <p:nvSpPr>
          <p:cNvPr id="54" name="TextBox 53"/>
          <p:cNvSpPr txBox="1"/>
          <p:nvPr/>
        </p:nvSpPr>
        <p:spPr>
          <a:xfrm>
            <a:off x="3631642" y="370837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13280" y="3213082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pic>
        <p:nvPicPr>
          <p:cNvPr id="3" name="Picture 2" descr="Screen Shot 2013-02-26 at 14.27.59.png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770" t="4397"/>
          <a:stretch/>
        </p:blipFill>
        <p:spPr>
          <a:xfrm>
            <a:off x="3825968" y="3282454"/>
            <a:ext cx="2263216" cy="862008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>
            <a:off x="613280" y="3369715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13280" y="3551746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613280" y="373377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50737" y="3459413"/>
            <a:ext cx="49680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RNA-</a:t>
            </a:r>
            <a:r>
              <a:rPr lang="en-US" sz="600" dirty="0" err="1" smtClean="0">
                <a:latin typeface="Arial"/>
                <a:cs typeface="Arial"/>
              </a:rPr>
              <a:t>seq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853656" y="704411"/>
            <a:ext cx="3728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10 kb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631642" y="354327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631642" y="337817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631642" y="321307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6169381" y="2301966"/>
            <a:ext cx="364290" cy="184666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s68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207897" y="1303191"/>
            <a:ext cx="287258" cy="184666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BF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6169381" y="3692934"/>
            <a:ext cx="364290" cy="184666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s68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6207897" y="3350832"/>
            <a:ext cx="287258" cy="184666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BF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48421" y="507169"/>
            <a:ext cx="2744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A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650672" y="475419"/>
            <a:ext cx="2744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B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777432" y="8364455"/>
            <a:ext cx="506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 smtClean="0">
                <a:latin typeface="Arial"/>
                <a:cs typeface="Arial"/>
              </a:rPr>
              <a:t>HOXC</a:t>
            </a:r>
            <a:endParaRPr lang="en-US" sz="800" i="1" dirty="0">
              <a:latin typeface="Arial"/>
              <a:cs typeface="Arial"/>
            </a:endParaRPr>
          </a:p>
        </p:txBody>
      </p:sp>
      <p:cxnSp>
        <p:nvCxnSpPr>
          <p:cNvPr id="95" name="Straight Arrow Connector 94"/>
          <p:cNvCxnSpPr/>
          <p:nvPr/>
        </p:nvCxnSpPr>
        <p:spPr>
          <a:xfrm>
            <a:off x="1919135" y="8604437"/>
            <a:ext cx="220134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518358" y="5127346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6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18358" y="5354695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21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518358" y="5582044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5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18358" y="5809393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518358" y="6036742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23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518358" y="6491440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18358" y="6718789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22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544006" y="6946138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7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544006" y="7173486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4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18358" y="6264091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4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49850" y="5873360"/>
            <a:ext cx="5696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3K27me3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233795" y="5193785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6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233795" y="5420310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7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233795" y="5646835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8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92643" y="6099885"/>
            <a:ext cx="52681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3K4me3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49850" y="7005985"/>
            <a:ext cx="5696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3K27me3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233795" y="6326410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6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33795" y="6552935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7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233795" y="6779460"/>
            <a:ext cx="385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CBX8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92643" y="7232512"/>
            <a:ext cx="52681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3K4me3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782249" y="4836402"/>
            <a:ext cx="3728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10 kb</a:t>
            </a:r>
            <a:endParaRPr lang="en-US" sz="600" dirty="0">
              <a:latin typeface="Arial"/>
              <a:cs typeface="Arial"/>
            </a:endParaRPr>
          </a:p>
        </p:txBody>
      </p:sp>
      <p:pic>
        <p:nvPicPr>
          <p:cNvPr id="118" name="Picture 117" descr="Screen Shot 2013-02-19 at 16.56.31.png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-406"/>
          <a:stretch/>
        </p:blipFill>
        <p:spPr>
          <a:xfrm>
            <a:off x="721054" y="4964562"/>
            <a:ext cx="2623384" cy="2587254"/>
          </a:xfrm>
          <a:prstGeom prst="rect">
            <a:avLst/>
          </a:prstGeom>
        </p:spPr>
      </p:pic>
      <p:pic>
        <p:nvPicPr>
          <p:cNvPr id="119" name="Picture 118" descr="Screen Shot 2013-02-26 at 14.17.22.png"/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43723" y="7421907"/>
            <a:ext cx="2628000" cy="943457"/>
          </a:xfrm>
          <a:prstGeom prst="rect">
            <a:avLst/>
          </a:prstGeom>
        </p:spPr>
      </p:pic>
      <p:sp>
        <p:nvSpPr>
          <p:cNvPr id="120" name="TextBox 119"/>
          <p:cNvSpPr txBox="1"/>
          <p:nvPr/>
        </p:nvSpPr>
        <p:spPr>
          <a:xfrm>
            <a:off x="549860" y="7389003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549860" y="7554103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549860" y="7731903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549860" y="7916053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81307" y="7675725"/>
            <a:ext cx="49680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RNA-</a:t>
            </a:r>
            <a:r>
              <a:rPr lang="en-US" sz="600" dirty="0" err="1" smtClean="0">
                <a:latin typeface="Arial"/>
                <a:cs typeface="Arial"/>
              </a:rPr>
              <a:t>seq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4589627" y="8350776"/>
            <a:ext cx="506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 smtClean="0">
                <a:latin typeface="Arial"/>
                <a:cs typeface="Arial"/>
              </a:rPr>
              <a:t>HOXD</a:t>
            </a:r>
            <a:endParaRPr lang="en-US" sz="800" i="1" dirty="0">
              <a:latin typeface="Arial"/>
              <a:cs typeface="Arial"/>
            </a:endParaRPr>
          </a:p>
        </p:txBody>
      </p:sp>
      <p:cxnSp>
        <p:nvCxnSpPr>
          <p:cNvPr id="132" name="Straight Arrow Connector 131"/>
          <p:cNvCxnSpPr/>
          <p:nvPr/>
        </p:nvCxnSpPr>
        <p:spPr>
          <a:xfrm>
            <a:off x="4705930" y="8567361"/>
            <a:ext cx="220134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3478062" y="508882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24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3478062" y="5320056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4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3478062" y="5551285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26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3503710" y="5782514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9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3478062" y="6013743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6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3478062" y="6476201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2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3478062" y="6707430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15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3503710" y="6938659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7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3503710" y="7169892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8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3503710" y="6244972"/>
            <a:ext cx="261610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8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3792876" y="4826458"/>
            <a:ext cx="3728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10 kb</a:t>
            </a:r>
            <a:endParaRPr lang="en-US" sz="600" dirty="0">
              <a:latin typeface="Arial"/>
              <a:cs typeface="Arial"/>
            </a:endParaRPr>
          </a:p>
        </p:txBody>
      </p:sp>
      <p:pic>
        <p:nvPicPr>
          <p:cNvPr id="155" name="Picture 154" descr="Screen Shot 2013-02-19 at 16.52.24.png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-1026" b="1"/>
          <a:stretch/>
        </p:blipFill>
        <p:spPr>
          <a:xfrm>
            <a:off x="3675800" y="4941274"/>
            <a:ext cx="2699507" cy="2610542"/>
          </a:xfrm>
          <a:prstGeom prst="rect">
            <a:avLst/>
          </a:prstGeom>
        </p:spPr>
      </p:pic>
      <p:sp>
        <p:nvSpPr>
          <p:cNvPr id="156" name="TextBox 155"/>
          <p:cNvSpPr txBox="1"/>
          <p:nvPr/>
        </p:nvSpPr>
        <p:spPr>
          <a:xfrm>
            <a:off x="3472183" y="739076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pic>
        <p:nvPicPr>
          <p:cNvPr id="157" name="Picture 156" descr="Screen Shot 2013-02-26 at 14.40.37.png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870" r="-747"/>
          <a:stretch/>
        </p:blipFill>
        <p:spPr>
          <a:xfrm>
            <a:off x="3675800" y="7445467"/>
            <a:ext cx="2721395" cy="918987"/>
          </a:xfrm>
          <a:prstGeom prst="rect">
            <a:avLst/>
          </a:prstGeom>
        </p:spPr>
      </p:pic>
      <p:sp>
        <p:nvSpPr>
          <p:cNvPr id="158" name="TextBox 157"/>
          <p:cNvSpPr txBox="1"/>
          <p:nvPr/>
        </p:nvSpPr>
        <p:spPr>
          <a:xfrm>
            <a:off x="3472183" y="757491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3472183" y="775906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3472183" y="7943217"/>
            <a:ext cx="28725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dirty="0" smtClean="0">
                <a:latin typeface="Arial"/>
                <a:cs typeface="Arial"/>
              </a:rPr>
              <a:t>50 –</a:t>
            </a:r>
            <a:endParaRPr lang="en-US" sz="400" dirty="0">
              <a:latin typeface="Arial"/>
              <a:cs typeface="Arial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6434663" y="6639467"/>
            <a:ext cx="364290" cy="184666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s68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6447363" y="5500992"/>
            <a:ext cx="287258" cy="184666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BF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6421963" y="7889128"/>
            <a:ext cx="364290" cy="184666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Hs68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6421963" y="7572489"/>
            <a:ext cx="287258" cy="184666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BF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488125" y="4607925"/>
            <a:ext cx="277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3523672" y="4607925"/>
            <a:ext cx="277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D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80162" y="64098"/>
            <a:ext cx="18710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smtClean="0">
                <a:latin typeface="Arial"/>
                <a:cs typeface="Arial"/>
              </a:rPr>
              <a:t>Additional file 5: Figure </a:t>
            </a:r>
            <a:r>
              <a:rPr lang="en-US" sz="1100" dirty="0" smtClean="0">
                <a:latin typeface="Arial"/>
                <a:cs typeface="Arial"/>
              </a:rPr>
              <a:t>S4</a:t>
            </a:r>
            <a:endParaRPr lang="en-US" sz="11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610054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166</Words>
  <Application>Microsoft Office PowerPoint</Application>
  <PresentationFormat>On-screen Show (4:3)</PresentationFormat>
  <Paragraphs>10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ancer Research UK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don Peters</dc:creator>
  <cp:lastModifiedBy>jolano</cp:lastModifiedBy>
  <cp:revision>16</cp:revision>
  <cp:lastPrinted>2013-02-26T15:32:43Z</cp:lastPrinted>
  <dcterms:created xsi:type="dcterms:W3CDTF">2013-02-19T16:50:44Z</dcterms:created>
  <dcterms:modified xsi:type="dcterms:W3CDTF">2014-01-15T12:40:55Z</dcterms:modified>
</cp:coreProperties>
</file>